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6" d="100"/>
          <a:sy n="36" d="100"/>
        </p:scale>
        <p:origin x="241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531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130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773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73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1584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2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1824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823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709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6681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3970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D3236-0BFC-466C-9DCA-AE59C60E226F}" type="datetimeFigureOut">
              <a:rPr lang="zh-CN" altLang="en-US" smtClean="0"/>
              <a:t>2019/8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AEE8D-5F5E-4B1E-9318-304ED803E6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9776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24" Type="http://schemas.openxmlformats.org/officeDocument/2006/relationships/image" Target="../media/image43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23" Type="http://schemas.openxmlformats.org/officeDocument/2006/relationships/image" Target="../media/image42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18" Type="http://schemas.openxmlformats.org/officeDocument/2006/relationships/image" Target="../media/image61.png"/><Relationship Id="rId3" Type="http://schemas.openxmlformats.org/officeDocument/2006/relationships/image" Target="../media/image46.png"/><Relationship Id="rId21" Type="http://schemas.openxmlformats.org/officeDocument/2006/relationships/image" Target="../media/image64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17" Type="http://schemas.openxmlformats.org/officeDocument/2006/relationships/image" Target="../media/image60.png"/><Relationship Id="rId2" Type="http://schemas.openxmlformats.org/officeDocument/2006/relationships/image" Target="../media/image45.png"/><Relationship Id="rId16" Type="http://schemas.openxmlformats.org/officeDocument/2006/relationships/image" Target="../media/image59.png"/><Relationship Id="rId20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5" Type="http://schemas.openxmlformats.org/officeDocument/2006/relationships/image" Target="../media/image58.png"/><Relationship Id="rId23" Type="http://schemas.openxmlformats.org/officeDocument/2006/relationships/image" Target="../media/image66.png"/><Relationship Id="rId10" Type="http://schemas.openxmlformats.org/officeDocument/2006/relationships/image" Target="../media/image53.png"/><Relationship Id="rId19" Type="http://schemas.openxmlformats.org/officeDocument/2006/relationships/image" Target="../media/image62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openxmlformats.org/officeDocument/2006/relationships/image" Target="../media/image57.png"/><Relationship Id="rId22" Type="http://schemas.openxmlformats.org/officeDocument/2006/relationships/image" Target="../media/image6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8C090CE8-0062-456B-8075-CD3BF44764C4}"/>
              </a:ext>
            </a:extLst>
          </p:cNvPr>
          <p:cNvGrpSpPr/>
          <p:nvPr/>
        </p:nvGrpSpPr>
        <p:grpSpPr>
          <a:xfrm>
            <a:off x="484093" y="433003"/>
            <a:ext cx="5784594" cy="314963"/>
            <a:chOff x="484093" y="-7186"/>
            <a:chExt cx="5784594" cy="314963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A88E4743-33E8-481B-8799-1636A5F81CDE}"/>
                </a:ext>
              </a:extLst>
            </p:cNvPr>
            <p:cNvSpPr/>
            <p:nvPr/>
          </p:nvSpPr>
          <p:spPr>
            <a:xfrm>
              <a:off x="484093" y="0"/>
              <a:ext cx="4798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/>
                <a:t>ACC</a:t>
              </a:r>
              <a:endParaRPr lang="zh-CN" altLang="en-US" sz="1400" dirty="0"/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DDDD5606-E18A-4985-B79A-8E89A6F51999}"/>
                </a:ext>
              </a:extLst>
            </p:cNvPr>
            <p:cNvSpPr/>
            <p:nvPr/>
          </p:nvSpPr>
          <p:spPr>
            <a:xfrm>
              <a:off x="2191813" y="-7186"/>
              <a:ext cx="4798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/>
                <a:t>ACC</a:t>
              </a:r>
              <a:endParaRPr lang="zh-CN" altLang="en-US" sz="1400" dirty="0"/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5A1DAC2F-DA56-45B3-9FE0-16C2AA6DA0D3}"/>
                </a:ext>
              </a:extLst>
            </p:cNvPr>
            <p:cNvSpPr/>
            <p:nvPr/>
          </p:nvSpPr>
          <p:spPr>
            <a:xfrm>
              <a:off x="3862191" y="-7186"/>
              <a:ext cx="5562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BLCA</a:t>
              </a: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C0DB02C6-437F-474F-A1D3-681A947756AB}"/>
                </a:ext>
              </a:extLst>
            </p:cNvPr>
            <p:cNvSpPr/>
            <p:nvPr/>
          </p:nvSpPr>
          <p:spPr>
            <a:xfrm>
              <a:off x="5712444" y="0"/>
              <a:ext cx="5562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BLCA</a:t>
              </a: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F0446FD8-A5FC-42FC-AEA6-B352BC2D3897}"/>
              </a:ext>
            </a:extLst>
          </p:cNvPr>
          <p:cNvGrpSpPr/>
          <p:nvPr/>
        </p:nvGrpSpPr>
        <p:grpSpPr>
          <a:xfrm>
            <a:off x="367179" y="2501598"/>
            <a:ext cx="5861164" cy="311370"/>
            <a:chOff x="420966" y="1568823"/>
            <a:chExt cx="5861164" cy="311370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122E0D5A-3372-4F16-9A50-2DA5A10B2945}"/>
                </a:ext>
              </a:extLst>
            </p:cNvPr>
            <p:cNvSpPr/>
            <p:nvPr/>
          </p:nvSpPr>
          <p:spPr>
            <a:xfrm>
              <a:off x="420966" y="1572416"/>
              <a:ext cx="57900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BRCA</a:t>
              </a: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E661DD89-A36E-435D-B52D-C565B28251AB}"/>
                </a:ext>
              </a:extLst>
            </p:cNvPr>
            <p:cNvSpPr/>
            <p:nvPr/>
          </p:nvSpPr>
          <p:spPr>
            <a:xfrm>
              <a:off x="2191813" y="1568823"/>
              <a:ext cx="57900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BRCA</a:t>
              </a: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D8367F82-B8A6-4740-B06E-704BEE08EB08}"/>
                </a:ext>
              </a:extLst>
            </p:cNvPr>
            <p:cNvSpPr/>
            <p:nvPr/>
          </p:nvSpPr>
          <p:spPr>
            <a:xfrm>
              <a:off x="3932287" y="1570602"/>
              <a:ext cx="5452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CESC</a:t>
              </a: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37514260-C9A2-48AF-A970-B6E5699DA44D}"/>
                </a:ext>
              </a:extLst>
            </p:cNvPr>
            <p:cNvSpPr/>
            <p:nvPr/>
          </p:nvSpPr>
          <p:spPr>
            <a:xfrm>
              <a:off x="5736916" y="1568823"/>
              <a:ext cx="5452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CESC</a:t>
              </a: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8504E000-74FD-485F-8119-67248E609265}"/>
              </a:ext>
            </a:extLst>
          </p:cNvPr>
          <p:cNvGrpSpPr/>
          <p:nvPr/>
        </p:nvGrpSpPr>
        <p:grpSpPr>
          <a:xfrm>
            <a:off x="351137" y="4505080"/>
            <a:ext cx="6100257" cy="307778"/>
            <a:chOff x="420966" y="3144831"/>
            <a:chExt cx="6100257" cy="307778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70DB0328-1BE9-4E33-82B7-2E55122C2189}"/>
                </a:ext>
              </a:extLst>
            </p:cNvPr>
            <p:cNvSpPr/>
            <p:nvPr/>
          </p:nvSpPr>
          <p:spPr>
            <a:xfrm>
              <a:off x="420966" y="3144832"/>
              <a:ext cx="58702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CHOL</a:t>
              </a: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CAE874CB-D85F-40EC-8DF8-9659D85313A1}"/>
                </a:ext>
              </a:extLst>
            </p:cNvPr>
            <p:cNvSpPr/>
            <p:nvPr/>
          </p:nvSpPr>
          <p:spPr>
            <a:xfrm>
              <a:off x="2257179" y="3144832"/>
              <a:ext cx="58702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CHOL</a:t>
              </a: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11CC05B8-A972-474C-B332-85E433A21F6F}"/>
                </a:ext>
              </a:extLst>
            </p:cNvPr>
            <p:cNvSpPr/>
            <p:nvPr/>
          </p:nvSpPr>
          <p:spPr>
            <a:xfrm>
              <a:off x="3932287" y="3144831"/>
              <a:ext cx="73148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400" dirty="0"/>
                <a:t>COAD</a:t>
              </a: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543F2B45-2DBE-4F66-9405-A653E10CF513}"/>
                </a:ext>
              </a:extLst>
            </p:cNvPr>
            <p:cNvSpPr/>
            <p:nvPr/>
          </p:nvSpPr>
          <p:spPr>
            <a:xfrm>
              <a:off x="5789741" y="3144831"/>
              <a:ext cx="73148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400" dirty="0"/>
                <a:t>COAD</a:t>
              </a: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5EAF5A29-3CAA-4FF9-A057-F7128DF3AF2B}"/>
              </a:ext>
            </a:extLst>
          </p:cNvPr>
          <p:cNvGrpSpPr/>
          <p:nvPr/>
        </p:nvGrpSpPr>
        <p:grpSpPr>
          <a:xfrm>
            <a:off x="420966" y="6519491"/>
            <a:ext cx="5865003" cy="307777"/>
            <a:chOff x="420966" y="6006147"/>
            <a:chExt cx="5865003" cy="307777"/>
          </a:xfrm>
        </p:grpSpPr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2F2C1329-33FE-490D-804D-F85194746123}"/>
                </a:ext>
              </a:extLst>
            </p:cNvPr>
            <p:cNvSpPr/>
            <p:nvPr/>
          </p:nvSpPr>
          <p:spPr>
            <a:xfrm>
              <a:off x="420966" y="6006147"/>
              <a:ext cx="56265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/>
                <a:t>DLCB</a:t>
              </a:r>
              <a:endParaRPr lang="zh-CN" altLang="en-US" sz="1400" dirty="0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694F9569-CB0D-47E1-B2F9-DDCAE6ADA0F5}"/>
                </a:ext>
              </a:extLst>
            </p:cNvPr>
            <p:cNvSpPr/>
            <p:nvPr/>
          </p:nvSpPr>
          <p:spPr>
            <a:xfrm>
              <a:off x="2257179" y="6006147"/>
              <a:ext cx="56265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/>
                <a:t>DLCB</a:t>
              </a:r>
              <a:endParaRPr lang="zh-CN" altLang="en-US" sz="1400" dirty="0"/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C997D2EC-3F21-499F-884A-0C92BA3B6067}"/>
                </a:ext>
              </a:extLst>
            </p:cNvPr>
            <p:cNvSpPr/>
            <p:nvPr/>
          </p:nvSpPr>
          <p:spPr>
            <a:xfrm>
              <a:off x="3960872" y="6006147"/>
              <a:ext cx="55322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ESCA</a:t>
              </a: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3DD1C204-D470-4656-AF77-AC1D551B069A}"/>
                </a:ext>
              </a:extLst>
            </p:cNvPr>
            <p:cNvSpPr/>
            <p:nvPr/>
          </p:nvSpPr>
          <p:spPr>
            <a:xfrm>
              <a:off x="5732741" y="6006147"/>
              <a:ext cx="55322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ESCA</a:t>
              </a:r>
            </a:p>
          </p:txBody>
        </p: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FF1D7FA4-FEE4-4737-AF19-1F972E122E8C}"/>
              </a:ext>
            </a:extLst>
          </p:cNvPr>
          <p:cNvGrpSpPr/>
          <p:nvPr/>
        </p:nvGrpSpPr>
        <p:grpSpPr>
          <a:xfrm>
            <a:off x="492652" y="8549943"/>
            <a:ext cx="5750726" cy="307777"/>
            <a:chOff x="492652" y="8373481"/>
            <a:chExt cx="5750726" cy="307777"/>
          </a:xfrm>
        </p:grpSpPr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29DADE7C-0CA0-4454-8A80-796781550A21}"/>
                </a:ext>
              </a:extLst>
            </p:cNvPr>
            <p:cNvSpPr/>
            <p:nvPr/>
          </p:nvSpPr>
          <p:spPr>
            <a:xfrm>
              <a:off x="492652" y="8373481"/>
              <a:ext cx="55015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GBM</a:t>
              </a: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14E2A10D-D04D-42F0-8FA6-68C4ABB08233}"/>
                </a:ext>
              </a:extLst>
            </p:cNvPr>
            <p:cNvSpPr/>
            <p:nvPr/>
          </p:nvSpPr>
          <p:spPr>
            <a:xfrm>
              <a:off x="2253085" y="8373481"/>
              <a:ext cx="55015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GBM</a:t>
              </a: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6B613916-7D35-479F-94C8-8969952D4B13}"/>
                </a:ext>
              </a:extLst>
            </p:cNvPr>
            <p:cNvSpPr/>
            <p:nvPr/>
          </p:nvSpPr>
          <p:spPr>
            <a:xfrm>
              <a:off x="3935704" y="8373481"/>
              <a:ext cx="59022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HNSC</a:t>
              </a: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0F7F6E9E-AD4E-4D28-AE24-7597A6258452}"/>
                </a:ext>
              </a:extLst>
            </p:cNvPr>
            <p:cNvSpPr/>
            <p:nvPr/>
          </p:nvSpPr>
          <p:spPr>
            <a:xfrm>
              <a:off x="5653152" y="8373481"/>
              <a:ext cx="59022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/>
                <a:t>HNSC</a:t>
              </a:r>
            </a:p>
          </p:txBody>
        </p:sp>
      </p:grpSp>
      <p:pic>
        <p:nvPicPr>
          <p:cNvPr id="33" name="图片 32">
            <a:extLst>
              <a:ext uri="{FF2B5EF4-FFF2-40B4-BE49-F238E27FC236}">
                <a16:creationId xmlns:a16="http://schemas.microsoft.com/office/drawing/2014/main" id="{806A55E4-7564-4F3A-8D2B-0F3B946B88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53" y="744394"/>
            <a:ext cx="1620000" cy="16200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DD8E3180-A2DD-4A2B-A0B9-01F5BB2872B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18049" y="744394"/>
            <a:ext cx="1594321" cy="160649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6D1F5FF9-7334-429E-A653-85F5A8C7B6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766122"/>
            <a:ext cx="1620000" cy="1626224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8138D326-02C6-4F42-8038-B833F25337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8049" y="2752082"/>
            <a:ext cx="1620000" cy="1628308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8C4D603C-6ABA-4526-A40B-C0C685D3801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764542"/>
            <a:ext cx="1620000" cy="162833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2FBC59D2-7760-4B32-8FD3-65D3178E6EE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92370" y="4781585"/>
            <a:ext cx="1620000" cy="1630425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29CFE713-04BE-4445-A55D-C60AFA2907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853" y="6765311"/>
            <a:ext cx="1620000" cy="1624148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28D51DEC-2D76-4F44-B65C-7D8DBE8A1B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64137" y="6775984"/>
            <a:ext cx="1620000" cy="1624159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60E61914-1B29-40C2-A724-185BC37B5C8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8876175"/>
            <a:ext cx="1620000" cy="1626239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A0022708-087A-4DB5-B365-6B5CC7EA542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240312" y="8857720"/>
            <a:ext cx="1620000" cy="162415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3CD06F98-023C-4046-9C50-F9A68F74FAE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69034" y="709558"/>
            <a:ext cx="1692638" cy="1695459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74F1969-43F0-4EE9-8ACE-13F83316CC6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45843" y="691994"/>
            <a:ext cx="1603723" cy="161176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A5BBEE9B-D0AC-40EC-835D-CE9343BA37C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89987" y="2771202"/>
            <a:ext cx="1598460" cy="1609188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32B11ACB-579D-47E7-A0E3-9F62D43AC67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989486" y="2752082"/>
            <a:ext cx="1595677" cy="1611768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9837E49A-5F42-42D3-85A6-181956E82D2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89987" y="4789364"/>
            <a:ext cx="1574150" cy="1582047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0DF3A4EC-1662-4619-A806-7C1DACC7C88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33936" y="4744304"/>
            <a:ext cx="1620001" cy="1636337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617DB53E-E794-421B-8B5F-7E6A17D5889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744404" y="6775984"/>
            <a:ext cx="1498618" cy="1503622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84CBD1E0-50EF-4C01-9EAB-B13F5200DB4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037023" y="6778599"/>
            <a:ext cx="1619999" cy="1633544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B864499B-F3F7-40AD-BDE4-CAD19C19F19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722726" y="8893314"/>
            <a:ext cx="1488610" cy="1503621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523FFF57-3239-466F-93C1-35BF00EA5B4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965164" y="8871126"/>
            <a:ext cx="1619999" cy="163633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7F595279-356C-48B7-8C8B-FBB70B85517C}"/>
              </a:ext>
            </a:extLst>
          </p:cNvPr>
          <p:cNvSpPr/>
          <p:nvPr/>
        </p:nvSpPr>
        <p:spPr>
          <a:xfrm>
            <a:off x="-74896" y="50187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</a:t>
            </a:r>
            <a:endParaRPr lang="zh-CN" altLang="en-US" dirty="0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3F055619-A32F-4845-B9CE-ABBCB61F993F}"/>
              </a:ext>
            </a:extLst>
          </p:cNvPr>
          <p:cNvSpPr/>
          <p:nvPr/>
        </p:nvSpPr>
        <p:spPr>
          <a:xfrm>
            <a:off x="1722726" y="501870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</a:t>
            </a:r>
            <a:endParaRPr lang="zh-CN" altLang="en-US" dirty="0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B0F26279-BF9D-43E9-86D3-D6B0F48D450F}"/>
              </a:ext>
            </a:extLst>
          </p:cNvPr>
          <p:cNvSpPr/>
          <p:nvPr/>
        </p:nvSpPr>
        <p:spPr>
          <a:xfrm>
            <a:off x="3353493" y="486259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C</a:t>
            </a:r>
            <a:endParaRPr lang="zh-CN" altLang="en-US" dirty="0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0B21E7DA-1D2C-44A3-98A1-192FCB479415}"/>
              </a:ext>
            </a:extLst>
          </p:cNvPr>
          <p:cNvSpPr/>
          <p:nvPr/>
        </p:nvSpPr>
        <p:spPr>
          <a:xfrm>
            <a:off x="4956652" y="500665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D</a:t>
            </a:r>
            <a:endParaRPr lang="zh-CN" altLang="en-US" dirty="0"/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D1F49C03-887C-4695-8057-1D0BF31BEDEA}"/>
              </a:ext>
            </a:extLst>
          </p:cNvPr>
          <p:cNvSpPr/>
          <p:nvPr/>
        </p:nvSpPr>
        <p:spPr>
          <a:xfrm>
            <a:off x="-73369" y="2517662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E</a:t>
            </a:r>
            <a:endParaRPr lang="zh-CN" altLang="en-US" dirty="0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54F56AC3-6479-4E40-84A7-81D4C9B7D258}"/>
              </a:ext>
            </a:extLst>
          </p:cNvPr>
          <p:cNvSpPr/>
          <p:nvPr/>
        </p:nvSpPr>
        <p:spPr>
          <a:xfrm>
            <a:off x="1729138" y="2505191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F</a:t>
            </a:r>
            <a:endParaRPr lang="zh-CN" altLang="en-US" dirty="0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91210BB5-EB75-4318-B38E-6FDC7C92149A}"/>
              </a:ext>
            </a:extLst>
          </p:cNvPr>
          <p:cNvSpPr/>
          <p:nvPr/>
        </p:nvSpPr>
        <p:spPr>
          <a:xfrm>
            <a:off x="3392928" y="250519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G</a:t>
            </a:r>
            <a:endParaRPr lang="zh-CN" altLang="en-US" dirty="0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95623E55-CF47-4403-A50A-9ACF1F493FF2}"/>
              </a:ext>
            </a:extLst>
          </p:cNvPr>
          <p:cNvSpPr/>
          <p:nvPr/>
        </p:nvSpPr>
        <p:spPr>
          <a:xfrm>
            <a:off x="5031254" y="251952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H</a:t>
            </a:r>
            <a:endParaRPr lang="zh-CN" altLang="en-US" dirty="0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A6E9C2B6-73ED-406E-B0BC-F962473A4BFE}"/>
              </a:ext>
            </a:extLst>
          </p:cNvPr>
          <p:cNvSpPr/>
          <p:nvPr/>
        </p:nvSpPr>
        <p:spPr>
          <a:xfrm>
            <a:off x="-27637" y="4456966"/>
            <a:ext cx="2616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I</a:t>
            </a:r>
            <a:endParaRPr lang="zh-CN" altLang="en-US" dirty="0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0A4675C8-6F40-4B2A-B42D-BB56FA2962FA}"/>
              </a:ext>
            </a:extLst>
          </p:cNvPr>
          <p:cNvSpPr/>
          <p:nvPr/>
        </p:nvSpPr>
        <p:spPr>
          <a:xfrm>
            <a:off x="1775607" y="4491342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J</a:t>
            </a:r>
            <a:endParaRPr lang="zh-CN" altLang="en-US" dirty="0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B655169A-D502-4315-AA14-5EAF41527199}"/>
              </a:ext>
            </a:extLst>
          </p:cNvPr>
          <p:cNvSpPr/>
          <p:nvPr/>
        </p:nvSpPr>
        <p:spPr>
          <a:xfrm>
            <a:off x="3413223" y="446932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K</a:t>
            </a:r>
            <a:endParaRPr lang="zh-CN" altLang="en-US" dirty="0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60680526-22D4-4AA4-9E13-B5C9E39BB60E}"/>
              </a:ext>
            </a:extLst>
          </p:cNvPr>
          <p:cNvSpPr/>
          <p:nvPr/>
        </p:nvSpPr>
        <p:spPr>
          <a:xfrm>
            <a:off x="5127783" y="4469328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L</a:t>
            </a:r>
            <a:endParaRPr lang="zh-CN" altLang="en-US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19618AB9-DD2C-45B8-9F56-931EBD8D3A87}"/>
              </a:ext>
            </a:extLst>
          </p:cNvPr>
          <p:cNvSpPr/>
          <p:nvPr/>
        </p:nvSpPr>
        <p:spPr>
          <a:xfrm>
            <a:off x="-30733" y="8608597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Q</a:t>
            </a:r>
            <a:endParaRPr lang="zh-CN" altLang="en-US" dirty="0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5EB0FE9D-227A-4A02-93EA-934943216904}"/>
              </a:ext>
            </a:extLst>
          </p:cNvPr>
          <p:cNvSpPr/>
          <p:nvPr/>
        </p:nvSpPr>
        <p:spPr>
          <a:xfrm>
            <a:off x="1677611" y="8570993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R</a:t>
            </a:r>
            <a:endParaRPr lang="zh-CN" altLang="en-US" dirty="0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F33C8A64-0F66-4F7E-9604-AE5C809D2C32}"/>
              </a:ext>
            </a:extLst>
          </p:cNvPr>
          <p:cNvSpPr/>
          <p:nvPr/>
        </p:nvSpPr>
        <p:spPr>
          <a:xfrm>
            <a:off x="43580" y="6504188"/>
            <a:ext cx="389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M</a:t>
            </a:r>
            <a:endParaRPr lang="zh-CN" altLang="en-US" dirty="0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CB609559-A432-4055-86E8-6E408F53BF83}"/>
              </a:ext>
            </a:extLst>
          </p:cNvPr>
          <p:cNvSpPr/>
          <p:nvPr/>
        </p:nvSpPr>
        <p:spPr>
          <a:xfrm>
            <a:off x="1696495" y="651959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N</a:t>
            </a:r>
            <a:endParaRPr lang="zh-CN" altLang="en-US" dirty="0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1D1507BC-9BB5-4BE0-88E5-60D01A52DFC0}"/>
              </a:ext>
            </a:extLst>
          </p:cNvPr>
          <p:cNvSpPr/>
          <p:nvPr/>
        </p:nvSpPr>
        <p:spPr>
          <a:xfrm>
            <a:off x="3332901" y="6529344"/>
            <a:ext cx="3369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O</a:t>
            </a:r>
            <a:endParaRPr lang="zh-CN" altLang="en-US" dirty="0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97D6BDA3-E42B-42E7-BFBC-E076F5BBCAF4}"/>
              </a:ext>
            </a:extLst>
          </p:cNvPr>
          <p:cNvSpPr/>
          <p:nvPr/>
        </p:nvSpPr>
        <p:spPr>
          <a:xfrm>
            <a:off x="4985816" y="6544754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P</a:t>
            </a:r>
            <a:endParaRPr lang="zh-CN" altLang="en-US" dirty="0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873418D5-10E8-4083-8A0F-03EEB891CFBC}"/>
              </a:ext>
            </a:extLst>
          </p:cNvPr>
          <p:cNvSpPr/>
          <p:nvPr/>
        </p:nvSpPr>
        <p:spPr>
          <a:xfrm>
            <a:off x="3256451" y="8599642"/>
            <a:ext cx="389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S</a:t>
            </a:r>
            <a:endParaRPr lang="zh-CN" altLang="en-US" dirty="0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5CED65E5-2F8F-4C2A-A02F-EE3929486356}"/>
              </a:ext>
            </a:extLst>
          </p:cNvPr>
          <p:cNvSpPr/>
          <p:nvPr/>
        </p:nvSpPr>
        <p:spPr>
          <a:xfrm>
            <a:off x="4909366" y="8615052"/>
            <a:ext cx="3513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98271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组合 38">
            <a:extLst>
              <a:ext uri="{FF2B5EF4-FFF2-40B4-BE49-F238E27FC236}">
                <a16:creationId xmlns:a16="http://schemas.microsoft.com/office/drawing/2014/main" id="{4BCC6B4D-BE5D-44FA-9021-2445BDBA0043}"/>
              </a:ext>
            </a:extLst>
          </p:cNvPr>
          <p:cNvGrpSpPr/>
          <p:nvPr/>
        </p:nvGrpSpPr>
        <p:grpSpPr>
          <a:xfrm>
            <a:off x="488998" y="2350173"/>
            <a:ext cx="5915905" cy="369332"/>
            <a:chOff x="488998" y="2205795"/>
            <a:chExt cx="5915905" cy="369332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DA6E9312-8A4E-48A6-B396-ADC80814DE3E}"/>
                </a:ext>
              </a:extLst>
            </p:cNvPr>
            <p:cNvSpPr/>
            <p:nvPr/>
          </p:nvSpPr>
          <p:spPr>
            <a:xfrm>
              <a:off x="488998" y="2205795"/>
              <a:ext cx="60625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RP</a:t>
              </a: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CD5CE2DA-C7E3-4DCC-8CF4-C79B5EB51D4C}"/>
                </a:ext>
              </a:extLst>
            </p:cNvPr>
            <p:cNvSpPr/>
            <p:nvPr/>
          </p:nvSpPr>
          <p:spPr>
            <a:xfrm>
              <a:off x="2347454" y="2205795"/>
              <a:ext cx="60625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RP</a:t>
              </a: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9F75006-AB54-4AFC-88F3-F5CFD1BABB94}"/>
                </a:ext>
              </a:extLst>
            </p:cNvPr>
            <p:cNvSpPr/>
            <p:nvPr/>
          </p:nvSpPr>
          <p:spPr>
            <a:xfrm>
              <a:off x="3955579" y="2205795"/>
              <a:ext cx="7104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AML</a:t>
              </a: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7491447C-CB45-4B8A-AB4C-5BD6B8622542}"/>
                </a:ext>
              </a:extLst>
            </p:cNvPr>
            <p:cNvSpPr/>
            <p:nvPr/>
          </p:nvSpPr>
          <p:spPr>
            <a:xfrm>
              <a:off x="5694452" y="2205795"/>
              <a:ext cx="7104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AML</a:t>
              </a: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ACB80D5A-B15F-4967-B449-22962538B731}"/>
              </a:ext>
            </a:extLst>
          </p:cNvPr>
          <p:cNvGrpSpPr/>
          <p:nvPr/>
        </p:nvGrpSpPr>
        <p:grpSpPr>
          <a:xfrm>
            <a:off x="526380" y="4343685"/>
            <a:ext cx="5905043" cy="369332"/>
            <a:chOff x="526380" y="4215349"/>
            <a:chExt cx="5905043" cy="369332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468D1E8C-D940-4499-9D4C-E068F53D8A25}"/>
                </a:ext>
              </a:extLst>
            </p:cNvPr>
            <p:cNvSpPr/>
            <p:nvPr/>
          </p:nvSpPr>
          <p:spPr>
            <a:xfrm>
              <a:off x="526380" y="4215349"/>
              <a:ext cx="56887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GG</a:t>
              </a: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A216937E-DD8D-40E1-835D-D54B3195D89F}"/>
                </a:ext>
              </a:extLst>
            </p:cNvPr>
            <p:cNvSpPr/>
            <p:nvPr/>
          </p:nvSpPr>
          <p:spPr>
            <a:xfrm>
              <a:off x="2406499" y="4215349"/>
              <a:ext cx="56887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GG</a:t>
              </a: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ACB45FE7-8300-4CC7-8570-3324CA027ECF}"/>
                </a:ext>
              </a:extLst>
            </p:cNvPr>
            <p:cNvSpPr/>
            <p:nvPr/>
          </p:nvSpPr>
          <p:spPr>
            <a:xfrm>
              <a:off x="3990832" y="4215349"/>
              <a:ext cx="6078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IHC</a:t>
              </a: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034AFE51-B349-4B83-BF09-9BA804481D9B}"/>
                </a:ext>
              </a:extLst>
            </p:cNvPr>
            <p:cNvSpPr/>
            <p:nvPr/>
          </p:nvSpPr>
          <p:spPr>
            <a:xfrm>
              <a:off x="5823564" y="4215349"/>
              <a:ext cx="6078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IHC</a:t>
              </a: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99A799DC-AD12-4B63-9588-EA8A3F15A919}"/>
              </a:ext>
            </a:extLst>
          </p:cNvPr>
          <p:cNvGrpSpPr/>
          <p:nvPr/>
        </p:nvGrpSpPr>
        <p:grpSpPr>
          <a:xfrm>
            <a:off x="488998" y="6264825"/>
            <a:ext cx="5980544" cy="369332"/>
            <a:chOff x="488998" y="6040237"/>
            <a:chExt cx="5980544" cy="369332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B0A6AA2E-C5E8-471F-9141-952DB291BBD7}"/>
                </a:ext>
              </a:extLst>
            </p:cNvPr>
            <p:cNvSpPr/>
            <p:nvPr/>
          </p:nvSpPr>
          <p:spPr>
            <a:xfrm>
              <a:off x="488998" y="6040237"/>
              <a:ext cx="69564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UAD</a:t>
              </a: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80145EE8-874F-4F89-971C-1C653979C292}"/>
                </a:ext>
              </a:extLst>
            </p:cNvPr>
            <p:cNvSpPr/>
            <p:nvPr/>
          </p:nvSpPr>
          <p:spPr>
            <a:xfrm>
              <a:off x="2384153" y="6040237"/>
              <a:ext cx="69564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UAD</a:t>
              </a: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7926D27F-2CE5-4E5A-BA63-0A7E8247592A}"/>
                </a:ext>
              </a:extLst>
            </p:cNvPr>
            <p:cNvSpPr/>
            <p:nvPr/>
          </p:nvSpPr>
          <p:spPr>
            <a:xfrm>
              <a:off x="4279308" y="6040237"/>
              <a:ext cx="65421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USC</a:t>
              </a: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3B8F7B7C-7E9D-437C-8095-226586DE277E}"/>
                </a:ext>
              </a:extLst>
            </p:cNvPr>
            <p:cNvSpPr/>
            <p:nvPr/>
          </p:nvSpPr>
          <p:spPr>
            <a:xfrm>
              <a:off x="5815324" y="6040237"/>
              <a:ext cx="65421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LUSC</a:t>
              </a:r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D629BD45-0AF1-437E-AFF2-13CEB194B46D}"/>
              </a:ext>
            </a:extLst>
          </p:cNvPr>
          <p:cNvGrpSpPr/>
          <p:nvPr/>
        </p:nvGrpSpPr>
        <p:grpSpPr>
          <a:xfrm>
            <a:off x="417183" y="8173269"/>
            <a:ext cx="5958038" cy="369332"/>
            <a:chOff x="417183" y="7724093"/>
            <a:chExt cx="5958038" cy="369332"/>
          </a:xfrm>
        </p:grpSpPr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01E661E0-3586-43F4-BE8E-C08D73D439D4}"/>
                </a:ext>
              </a:extLst>
            </p:cNvPr>
            <p:cNvSpPr/>
            <p:nvPr/>
          </p:nvSpPr>
          <p:spPr>
            <a:xfrm>
              <a:off x="417183" y="7724093"/>
              <a:ext cx="74988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MESO</a:t>
              </a: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EAC30387-B2D3-4E09-9198-DB89697E042E}"/>
                </a:ext>
              </a:extLst>
            </p:cNvPr>
            <p:cNvSpPr/>
            <p:nvPr/>
          </p:nvSpPr>
          <p:spPr>
            <a:xfrm>
              <a:off x="2355849" y="7724093"/>
              <a:ext cx="74988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MESO</a:t>
              </a: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769641CB-9A01-4FE0-9B38-459E08EC5751}"/>
                </a:ext>
              </a:extLst>
            </p:cNvPr>
            <p:cNvSpPr/>
            <p:nvPr/>
          </p:nvSpPr>
          <p:spPr>
            <a:xfrm>
              <a:off x="4330108" y="7724093"/>
              <a:ext cx="46557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OV</a:t>
              </a: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4687A0A6-9F64-4D9E-BCB7-0E651C6ABB68}"/>
                </a:ext>
              </a:extLst>
            </p:cNvPr>
            <p:cNvSpPr/>
            <p:nvPr/>
          </p:nvSpPr>
          <p:spPr>
            <a:xfrm>
              <a:off x="5909644" y="7724093"/>
              <a:ext cx="46557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OV</a:t>
              </a:r>
            </a:p>
          </p:txBody>
        </p: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0F7E8209-6AC6-4E39-BC97-40C2D9DCD1FC}"/>
              </a:ext>
            </a:extLst>
          </p:cNvPr>
          <p:cNvGrpSpPr/>
          <p:nvPr/>
        </p:nvGrpSpPr>
        <p:grpSpPr>
          <a:xfrm>
            <a:off x="391878" y="9966438"/>
            <a:ext cx="6161518" cy="401415"/>
            <a:chOff x="391878" y="9709766"/>
            <a:chExt cx="6161518" cy="401415"/>
          </a:xfrm>
        </p:grpSpPr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FD72E7ED-A9FF-4D8D-BFF1-B1BB8072DF64}"/>
                </a:ext>
              </a:extLst>
            </p:cNvPr>
            <p:cNvSpPr/>
            <p:nvPr/>
          </p:nvSpPr>
          <p:spPr>
            <a:xfrm>
              <a:off x="391878" y="9733647"/>
              <a:ext cx="69506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AAD</a:t>
              </a: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80F4C128-C7D4-412F-B1C7-D45199BB96DC}"/>
                </a:ext>
              </a:extLst>
            </p:cNvPr>
            <p:cNvSpPr/>
            <p:nvPr/>
          </p:nvSpPr>
          <p:spPr>
            <a:xfrm>
              <a:off x="2338858" y="9741849"/>
              <a:ext cx="69506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AAD</a:t>
              </a: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10ADFF69-4EF7-4AAC-9DEE-EE85CE6324E6}"/>
                </a:ext>
              </a:extLst>
            </p:cNvPr>
            <p:cNvSpPr/>
            <p:nvPr/>
          </p:nvSpPr>
          <p:spPr>
            <a:xfrm>
              <a:off x="4260809" y="9709766"/>
              <a:ext cx="69121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CPG</a:t>
              </a: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BF4A3019-9DC3-4E8F-9362-24AA630BB0C6}"/>
                </a:ext>
              </a:extLst>
            </p:cNvPr>
            <p:cNvSpPr/>
            <p:nvPr/>
          </p:nvSpPr>
          <p:spPr>
            <a:xfrm>
              <a:off x="5862181" y="9709766"/>
              <a:ext cx="69121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CPG</a:t>
              </a: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3F314A8F-F766-48FF-AB25-F0CEA2538189}"/>
              </a:ext>
            </a:extLst>
          </p:cNvPr>
          <p:cNvGrpSpPr/>
          <p:nvPr/>
        </p:nvGrpSpPr>
        <p:grpSpPr>
          <a:xfrm>
            <a:off x="336115" y="377087"/>
            <a:ext cx="5922108" cy="369332"/>
            <a:chOff x="484093" y="9473241"/>
            <a:chExt cx="5922108" cy="369332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5D768A41-94B2-4747-9E85-8D86F305C8F8}"/>
                </a:ext>
              </a:extLst>
            </p:cNvPr>
            <p:cNvSpPr/>
            <p:nvPr/>
          </p:nvSpPr>
          <p:spPr>
            <a:xfrm>
              <a:off x="484093" y="9473241"/>
              <a:ext cx="63030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CH</a:t>
              </a: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F44A8430-9C04-4E18-8FF1-7AA382F7ACB7}"/>
                </a:ext>
              </a:extLst>
            </p:cNvPr>
            <p:cNvSpPr/>
            <p:nvPr/>
          </p:nvSpPr>
          <p:spPr>
            <a:xfrm>
              <a:off x="2167456" y="9473241"/>
              <a:ext cx="63030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CH</a:t>
              </a: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2293EFA1-0E6F-46E5-AA0D-58E93D9A106A}"/>
                </a:ext>
              </a:extLst>
            </p:cNvPr>
            <p:cNvSpPr/>
            <p:nvPr/>
          </p:nvSpPr>
          <p:spPr>
            <a:xfrm>
              <a:off x="4201272" y="9473241"/>
              <a:ext cx="60901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RC</a:t>
              </a: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58A83E15-0D63-4B55-9B05-21B8BE4AFC33}"/>
                </a:ext>
              </a:extLst>
            </p:cNvPr>
            <p:cNvSpPr/>
            <p:nvPr/>
          </p:nvSpPr>
          <p:spPr>
            <a:xfrm>
              <a:off x="5797188" y="9473241"/>
              <a:ext cx="60901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KIRC</a:t>
              </a:r>
            </a:p>
          </p:txBody>
        </p:sp>
      </p:grpSp>
      <p:pic>
        <p:nvPicPr>
          <p:cNvPr id="34" name="图片 33">
            <a:extLst>
              <a:ext uri="{FF2B5EF4-FFF2-40B4-BE49-F238E27FC236}">
                <a16:creationId xmlns:a16="http://schemas.microsoft.com/office/drawing/2014/main" id="{8D8F8320-BBBC-4DE9-A727-F07BDD3FFE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0122"/>
            <a:ext cx="1620000" cy="162833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56B8E87F-28FE-46BA-A923-895FC39384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3403" y="679885"/>
            <a:ext cx="1620000" cy="1628319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E17B2B9D-D05C-4370-B793-698C31B56B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20" y="2662186"/>
            <a:ext cx="1620000" cy="1622075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0ADA8A9E-ACBA-467F-98BD-6AD6AFF2BC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2461" y="2734839"/>
            <a:ext cx="1620000" cy="1617928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067E3596-59DC-4F68-84F8-EF1056DBFA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520" y="4685152"/>
            <a:ext cx="1620000" cy="1624164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333B9FE2-41D4-4436-9AE7-F25A6319BD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3335" y="4645187"/>
            <a:ext cx="1620000" cy="1617928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1405DA3B-FFA6-4B7E-B57D-F6058B64AE5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20" y="6612809"/>
            <a:ext cx="1620000" cy="1589472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3E17B428-5F20-4173-A1F2-EA584F24BB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29520" y="6612809"/>
            <a:ext cx="1620000" cy="1634595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8B046A5D-7CC0-4363-9F2E-57FF538EC6F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8457305"/>
            <a:ext cx="1620000" cy="1626231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42491790-3979-4CFD-9184-BBF4F7ADBE7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13566" y="8452590"/>
            <a:ext cx="1620000" cy="1622082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D095C1B8-C1ED-487C-A3FE-1B3C63D53F8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472" y="10423114"/>
            <a:ext cx="1620000" cy="162000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FD8940BD-A7D4-4112-B5DC-24D7D72EF85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50168" y="10335734"/>
            <a:ext cx="1620000" cy="162417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91530D0-6127-473B-ACDD-145E603742E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92998" y="710619"/>
            <a:ext cx="1620000" cy="1597585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541BC9F4-A41D-4FB6-A649-A5411E18CC7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719490" y="2719505"/>
            <a:ext cx="1620000" cy="1611766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A9D9ADB1-13B3-463A-AC56-8DF79D9C9B3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099644" y="2715388"/>
            <a:ext cx="1620000" cy="16200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C05FA83C-07A8-4311-B0A0-D8747969E66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719490" y="4653059"/>
            <a:ext cx="1620000" cy="1626239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840F7734-352B-47CE-9735-18F98A200D0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099644" y="4670054"/>
            <a:ext cx="1620000" cy="162415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5B1B9C7-9B18-4A47-A7FC-1099294AEDF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726653" y="710619"/>
            <a:ext cx="1547155" cy="1560135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2F23B550-7B0E-4D5A-A536-8EC3E859E75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742194" y="6615590"/>
            <a:ext cx="1571331" cy="1579227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AA3E1CE1-362E-4F2B-A6A5-2E30B1528A4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211021" y="6658353"/>
            <a:ext cx="1508623" cy="151619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7A8D2A6E-B38A-4BF5-AE09-2006EF6129DE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712653" y="8437861"/>
            <a:ext cx="1581511" cy="1589472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F7773F0-9476-436C-8972-ED904A87DA3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130683" y="8452591"/>
            <a:ext cx="1582315" cy="159559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327B39E0-248A-48E3-90AF-085A49D30B78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719441" y="10428138"/>
            <a:ext cx="1620000" cy="1633614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E6408642-DCE4-4E49-9F44-4B799E29756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180895" y="10319911"/>
            <a:ext cx="1620001" cy="1633614"/>
          </a:xfrm>
          <a:prstGeom prst="rect">
            <a:avLst/>
          </a:prstGeom>
        </p:spPr>
      </p:pic>
      <p:sp>
        <p:nvSpPr>
          <p:cNvPr id="59" name="矩形 58">
            <a:extLst>
              <a:ext uri="{FF2B5EF4-FFF2-40B4-BE49-F238E27FC236}">
                <a16:creationId xmlns:a16="http://schemas.microsoft.com/office/drawing/2014/main" id="{D35C2023-C6BD-46F2-AE76-3E06FF27E881}"/>
              </a:ext>
            </a:extLst>
          </p:cNvPr>
          <p:cNvSpPr/>
          <p:nvPr/>
        </p:nvSpPr>
        <p:spPr>
          <a:xfrm>
            <a:off x="-74896" y="50187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U</a:t>
            </a:r>
            <a:endParaRPr lang="zh-CN" altLang="en-US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CE54683D-DEBD-4D30-8662-9B9043D5CDF6}"/>
              </a:ext>
            </a:extLst>
          </p:cNvPr>
          <p:cNvSpPr/>
          <p:nvPr/>
        </p:nvSpPr>
        <p:spPr>
          <a:xfrm>
            <a:off x="1722726" y="50187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V</a:t>
            </a:r>
            <a:endParaRPr lang="zh-CN" altLang="en-US" dirty="0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F51B35D8-798C-4E11-BE43-EE12B7DAD52B}"/>
              </a:ext>
            </a:extLst>
          </p:cNvPr>
          <p:cNvSpPr/>
          <p:nvPr/>
        </p:nvSpPr>
        <p:spPr>
          <a:xfrm>
            <a:off x="3353493" y="486259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W</a:t>
            </a:r>
            <a:endParaRPr lang="zh-CN" altLang="en-US" dirty="0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862AB651-ECA4-4168-B89C-9FC2FD5D2D1D}"/>
              </a:ext>
            </a:extLst>
          </p:cNvPr>
          <p:cNvSpPr/>
          <p:nvPr/>
        </p:nvSpPr>
        <p:spPr>
          <a:xfrm>
            <a:off x="4956652" y="500665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X</a:t>
            </a:r>
            <a:endParaRPr lang="zh-CN" altLang="en-US" dirty="0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AF0F911E-B05C-47B4-845E-A7DC565A7C11}"/>
              </a:ext>
            </a:extLst>
          </p:cNvPr>
          <p:cNvSpPr/>
          <p:nvPr/>
        </p:nvSpPr>
        <p:spPr>
          <a:xfrm>
            <a:off x="-73369" y="2517662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Y</a:t>
            </a:r>
            <a:endParaRPr lang="zh-CN" altLang="en-US" dirty="0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8D6CA9A9-51A8-41B9-9807-E83481B7489E}"/>
              </a:ext>
            </a:extLst>
          </p:cNvPr>
          <p:cNvSpPr/>
          <p:nvPr/>
        </p:nvSpPr>
        <p:spPr>
          <a:xfrm>
            <a:off x="1729138" y="2505191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Z</a:t>
            </a:r>
            <a:endParaRPr lang="zh-CN" altLang="en-US" dirty="0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8743FBCF-A429-463B-87D0-254B3315EBFC}"/>
              </a:ext>
            </a:extLst>
          </p:cNvPr>
          <p:cNvSpPr/>
          <p:nvPr/>
        </p:nvSpPr>
        <p:spPr>
          <a:xfrm>
            <a:off x="3392928" y="2505191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A</a:t>
            </a:r>
            <a:endParaRPr lang="zh-CN" altLang="en-US" dirty="0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83AD247C-3A47-461F-BAE4-BC5C63F385E3}"/>
              </a:ext>
            </a:extLst>
          </p:cNvPr>
          <p:cNvSpPr/>
          <p:nvPr/>
        </p:nvSpPr>
        <p:spPr>
          <a:xfrm>
            <a:off x="5031254" y="251952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B</a:t>
            </a:r>
            <a:endParaRPr lang="zh-CN" altLang="en-US" dirty="0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A34BA931-0A2C-4373-B0A8-3F0498DDE0A2}"/>
              </a:ext>
            </a:extLst>
          </p:cNvPr>
          <p:cNvSpPr/>
          <p:nvPr/>
        </p:nvSpPr>
        <p:spPr>
          <a:xfrm>
            <a:off x="-27637" y="445696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C</a:t>
            </a:r>
            <a:endParaRPr lang="zh-CN" altLang="en-US" dirty="0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07A6CC33-C9BA-4B32-8AD3-A6072C55DFAA}"/>
              </a:ext>
            </a:extLst>
          </p:cNvPr>
          <p:cNvSpPr/>
          <p:nvPr/>
        </p:nvSpPr>
        <p:spPr>
          <a:xfrm>
            <a:off x="1775607" y="4491342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D</a:t>
            </a:r>
            <a:endParaRPr lang="zh-CN" altLang="en-US" dirty="0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90CD1BB3-7C3C-4218-B098-FFC83ACF8864}"/>
              </a:ext>
            </a:extLst>
          </p:cNvPr>
          <p:cNvSpPr/>
          <p:nvPr/>
        </p:nvSpPr>
        <p:spPr>
          <a:xfrm>
            <a:off x="3413223" y="4469328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E</a:t>
            </a:r>
            <a:endParaRPr lang="zh-CN" altLang="en-US" dirty="0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9D43397B-7FBB-4667-9A1A-68AB253504BB}"/>
              </a:ext>
            </a:extLst>
          </p:cNvPr>
          <p:cNvSpPr/>
          <p:nvPr/>
        </p:nvSpPr>
        <p:spPr>
          <a:xfrm>
            <a:off x="5127783" y="4469328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F</a:t>
            </a:r>
            <a:endParaRPr lang="zh-CN" altLang="en-US" dirty="0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FA923432-D104-44E3-B7E1-ED69392D6169}"/>
              </a:ext>
            </a:extLst>
          </p:cNvPr>
          <p:cNvSpPr/>
          <p:nvPr/>
        </p:nvSpPr>
        <p:spPr>
          <a:xfrm>
            <a:off x="-30733" y="8608597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K</a:t>
            </a:r>
            <a:endParaRPr lang="zh-CN" altLang="en-US" dirty="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359A31B7-C346-4EA6-938C-523F682DF10B}"/>
              </a:ext>
            </a:extLst>
          </p:cNvPr>
          <p:cNvSpPr/>
          <p:nvPr/>
        </p:nvSpPr>
        <p:spPr>
          <a:xfrm>
            <a:off x="1677611" y="8570993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L</a:t>
            </a:r>
            <a:endParaRPr lang="zh-CN" altLang="en-US" dirty="0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C644E689-2B8D-49E3-A31B-6AC691C966C4}"/>
              </a:ext>
            </a:extLst>
          </p:cNvPr>
          <p:cNvSpPr/>
          <p:nvPr/>
        </p:nvSpPr>
        <p:spPr>
          <a:xfrm>
            <a:off x="43580" y="6504188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G</a:t>
            </a:r>
            <a:endParaRPr lang="zh-CN" altLang="en-US" dirty="0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A229C675-E950-4379-8B12-52DFC64D9546}"/>
              </a:ext>
            </a:extLst>
          </p:cNvPr>
          <p:cNvSpPr/>
          <p:nvPr/>
        </p:nvSpPr>
        <p:spPr>
          <a:xfrm>
            <a:off x="1696495" y="6519598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H</a:t>
            </a:r>
            <a:endParaRPr lang="zh-CN" altLang="en-US" dirty="0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D1353FA3-2FF4-488D-BBB4-3CD8FFBA44D8}"/>
              </a:ext>
            </a:extLst>
          </p:cNvPr>
          <p:cNvSpPr/>
          <p:nvPr/>
        </p:nvSpPr>
        <p:spPr>
          <a:xfrm>
            <a:off x="3332901" y="6529344"/>
            <a:ext cx="3754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I</a:t>
            </a:r>
            <a:endParaRPr lang="zh-CN" altLang="en-US" dirty="0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7AC3B223-BB6E-451E-814E-E24FE7E2C08A}"/>
              </a:ext>
            </a:extLst>
          </p:cNvPr>
          <p:cNvSpPr/>
          <p:nvPr/>
        </p:nvSpPr>
        <p:spPr>
          <a:xfrm>
            <a:off x="4985816" y="654475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J</a:t>
            </a:r>
            <a:endParaRPr lang="zh-CN" altLang="en-US" dirty="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742C85EF-69E8-4F84-8DA9-B3A9690547A7}"/>
              </a:ext>
            </a:extLst>
          </p:cNvPr>
          <p:cNvSpPr/>
          <p:nvPr/>
        </p:nvSpPr>
        <p:spPr>
          <a:xfrm>
            <a:off x="3256451" y="8599642"/>
            <a:ext cx="6991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M</a:t>
            </a:r>
            <a:endParaRPr lang="zh-CN" altLang="en-US" dirty="0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CCA84046-4F83-49F5-9A77-000FF5CFBCB6}"/>
              </a:ext>
            </a:extLst>
          </p:cNvPr>
          <p:cNvSpPr/>
          <p:nvPr/>
        </p:nvSpPr>
        <p:spPr>
          <a:xfrm>
            <a:off x="4909366" y="8615052"/>
            <a:ext cx="5038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AN</a:t>
            </a:r>
            <a:endParaRPr lang="zh-CN" altLang="en-US" dirty="0"/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0ECE8512-B666-4319-A755-7CDB09292E8C}"/>
              </a:ext>
            </a:extLst>
          </p:cNvPr>
          <p:cNvSpPr/>
          <p:nvPr/>
        </p:nvSpPr>
        <p:spPr>
          <a:xfrm>
            <a:off x="-81533" y="10284997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O</a:t>
            </a:r>
            <a:endParaRPr lang="zh-CN" altLang="en-US" dirty="0"/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FF4B1406-7C74-44FA-819A-06DD3A7320A2}"/>
              </a:ext>
            </a:extLst>
          </p:cNvPr>
          <p:cNvSpPr/>
          <p:nvPr/>
        </p:nvSpPr>
        <p:spPr>
          <a:xfrm>
            <a:off x="1626811" y="10247393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P</a:t>
            </a:r>
            <a:endParaRPr lang="zh-CN" altLang="en-US" dirty="0"/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84BBE4FF-8D29-49C8-8C6D-53BE6FB3CE7B}"/>
              </a:ext>
            </a:extLst>
          </p:cNvPr>
          <p:cNvSpPr/>
          <p:nvPr/>
        </p:nvSpPr>
        <p:spPr>
          <a:xfrm>
            <a:off x="3205651" y="10276042"/>
            <a:ext cx="6991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Q</a:t>
            </a:r>
            <a:endParaRPr lang="zh-CN" altLang="en-US" dirty="0"/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CFF9D35F-391D-4B70-8FF3-91F24FB71462}"/>
              </a:ext>
            </a:extLst>
          </p:cNvPr>
          <p:cNvSpPr/>
          <p:nvPr/>
        </p:nvSpPr>
        <p:spPr>
          <a:xfrm>
            <a:off x="4858566" y="10291452"/>
            <a:ext cx="5038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A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083264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>
            <a:extLst>
              <a:ext uri="{FF2B5EF4-FFF2-40B4-BE49-F238E27FC236}">
                <a16:creationId xmlns:a16="http://schemas.microsoft.com/office/drawing/2014/main" id="{46BF6A3E-87FA-40BB-8DA5-5FC1382FB0E6}"/>
              </a:ext>
            </a:extLst>
          </p:cNvPr>
          <p:cNvGrpSpPr/>
          <p:nvPr/>
        </p:nvGrpSpPr>
        <p:grpSpPr>
          <a:xfrm>
            <a:off x="399796" y="2013099"/>
            <a:ext cx="6094807" cy="369332"/>
            <a:chOff x="399796" y="1227039"/>
            <a:chExt cx="6094807" cy="369332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4958FCE3-6D84-4DD3-A738-0499CD24ABF8}"/>
                </a:ext>
              </a:extLst>
            </p:cNvPr>
            <p:cNvSpPr/>
            <p:nvPr/>
          </p:nvSpPr>
          <p:spPr>
            <a:xfrm>
              <a:off x="399796" y="1227039"/>
              <a:ext cx="66826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SARC</a:t>
              </a: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13E8976C-1FBF-4962-9C06-61DD61D3B88C}"/>
                </a:ext>
              </a:extLst>
            </p:cNvPr>
            <p:cNvSpPr/>
            <p:nvPr/>
          </p:nvSpPr>
          <p:spPr>
            <a:xfrm>
              <a:off x="1931817" y="1227039"/>
              <a:ext cx="66826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SARC</a:t>
              </a: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2502B847-242C-4A2B-84DB-CB415DB85A68}"/>
                </a:ext>
              </a:extLst>
            </p:cNvPr>
            <p:cNvSpPr/>
            <p:nvPr/>
          </p:nvSpPr>
          <p:spPr>
            <a:xfrm>
              <a:off x="3741515" y="1227039"/>
              <a:ext cx="7225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SKCM</a:t>
              </a: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1A26BE2C-FDCD-4312-992D-F77727773F7E}"/>
                </a:ext>
              </a:extLst>
            </p:cNvPr>
            <p:cNvSpPr/>
            <p:nvPr/>
          </p:nvSpPr>
          <p:spPr>
            <a:xfrm>
              <a:off x="5772098" y="1227039"/>
              <a:ext cx="7225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SKCM</a:t>
              </a: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9FFA2A35-E561-496C-8F15-7048B8F6C829}"/>
              </a:ext>
            </a:extLst>
          </p:cNvPr>
          <p:cNvGrpSpPr/>
          <p:nvPr/>
        </p:nvGrpSpPr>
        <p:grpSpPr>
          <a:xfrm>
            <a:off x="399796" y="3922110"/>
            <a:ext cx="6045179" cy="369332"/>
            <a:chOff x="399796" y="2847291"/>
            <a:chExt cx="6045179" cy="369332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3C09048E-C7FE-46C2-BE48-210B2373BF8A}"/>
                </a:ext>
              </a:extLst>
            </p:cNvPr>
            <p:cNvSpPr/>
            <p:nvPr/>
          </p:nvSpPr>
          <p:spPr>
            <a:xfrm>
              <a:off x="399796" y="2847291"/>
              <a:ext cx="65877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dirty="0"/>
                <a:t>STAD</a:t>
              </a: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850A1AE0-C256-4B3E-92CD-68E0B8627AB9}"/>
                </a:ext>
              </a:extLst>
            </p:cNvPr>
            <p:cNvSpPr/>
            <p:nvPr/>
          </p:nvSpPr>
          <p:spPr>
            <a:xfrm>
              <a:off x="1957136" y="2847291"/>
              <a:ext cx="65877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dirty="0"/>
                <a:t>STAD</a:t>
              </a: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0450618F-19E3-48EA-B254-869B1A0C40CD}"/>
                </a:ext>
              </a:extLst>
            </p:cNvPr>
            <p:cNvSpPr/>
            <p:nvPr/>
          </p:nvSpPr>
          <p:spPr>
            <a:xfrm>
              <a:off x="3791143" y="2847291"/>
              <a:ext cx="67287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GCT</a:t>
              </a: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0E6D40BF-65A7-4246-B1D9-4FD6087610B0}"/>
                </a:ext>
              </a:extLst>
            </p:cNvPr>
            <p:cNvSpPr/>
            <p:nvPr/>
          </p:nvSpPr>
          <p:spPr>
            <a:xfrm>
              <a:off x="5772098" y="2847291"/>
              <a:ext cx="67287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GCT</a:t>
              </a:r>
            </a:p>
          </p:txBody>
        </p: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1F294B49-8F4E-4D4F-A7F2-7FF9C04623D9}"/>
              </a:ext>
            </a:extLst>
          </p:cNvPr>
          <p:cNvGrpSpPr/>
          <p:nvPr/>
        </p:nvGrpSpPr>
        <p:grpSpPr>
          <a:xfrm>
            <a:off x="360939" y="5975499"/>
            <a:ext cx="6179480" cy="369332"/>
            <a:chOff x="360939" y="4611924"/>
            <a:chExt cx="6179480" cy="369332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B058DB1C-D882-4D85-AFD3-3F18601D1F68}"/>
                </a:ext>
              </a:extLst>
            </p:cNvPr>
            <p:cNvSpPr/>
            <p:nvPr/>
          </p:nvSpPr>
          <p:spPr>
            <a:xfrm>
              <a:off x="360939" y="4611924"/>
              <a:ext cx="69762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HCA</a:t>
              </a: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CC144E97-4BFE-4009-91F5-DB3B061BB671}"/>
                </a:ext>
              </a:extLst>
            </p:cNvPr>
            <p:cNvSpPr/>
            <p:nvPr/>
          </p:nvSpPr>
          <p:spPr>
            <a:xfrm>
              <a:off x="3791143" y="4611924"/>
              <a:ext cx="7505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HYM</a:t>
              </a: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B8535781-4C24-473C-B363-7F30CBAF4B43}"/>
                </a:ext>
              </a:extLst>
            </p:cNvPr>
            <p:cNvSpPr/>
            <p:nvPr/>
          </p:nvSpPr>
          <p:spPr>
            <a:xfrm>
              <a:off x="2085755" y="4611924"/>
              <a:ext cx="69762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HCA</a:t>
              </a: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ED83449E-3EB8-4487-8351-19FD027D6B95}"/>
                </a:ext>
              </a:extLst>
            </p:cNvPr>
            <p:cNvSpPr/>
            <p:nvPr/>
          </p:nvSpPr>
          <p:spPr>
            <a:xfrm>
              <a:off x="5789893" y="4611924"/>
              <a:ext cx="7505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THYM</a:t>
              </a: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1808EE3D-DA14-4963-A40B-9661A0257FB2}"/>
              </a:ext>
            </a:extLst>
          </p:cNvPr>
          <p:cNvGrpSpPr/>
          <p:nvPr/>
        </p:nvGrpSpPr>
        <p:grpSpPr>
          <a:xfrm>
            <a:off x="360939" y="8093057"/>
            <a:ext cx="6063279" cy="409619"/>
            <a:chOff x="360939" y="6504892"/>
            <a:chExt cx="6063279" cy="409619"/>
          </a:xfrm>
        </p:grpSpPr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4C304ACA-6462-4BD0-9773-E9E8D5766ED0}"/>
                </a:ext>
              </a:extLst>
            </p:cNvPr>
            <p:cNvSpPr/>
            <p:nvPr/>
          </p:nvSpPr>
          <p:spPr>
            <a:xfrm>
              <a:off x="360939" y="6504892"/>
              <a:ext cx="68852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UCEC</a:t>
              </a: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0E6E05FC-D798-4609-AE2E-740F0A7EB21C}"/>
                </a:ext>
              </a:extLst>
            </p:cNvPr>
            <p:cNvSpPr/>
            <p:nvPr/>
          </p:nvSpPr>
          <p:spPr>
            <a:xfrm>
              <a:off x="2094860" y="6545179"/>
              <a:ext cx="68852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UCEC</a:t>
              </a: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9F8743CE-24A8-4078-A412-73168DE5DFA3}"/>
                </a:ext>
              </a:extLst>
            </p:cNvPr>
            <p:cNvSpPr/>
            <p:nvPr/>
          </p:nvSpPr>
          <p:spPr>
            <a:xfrm>
              <a:off x="3980297" y="6545179"/>
              <a:ext cx="56137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UCS</a:t>
              </a: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682CAF8F-EBC0-4447-B812-C017A057FDCE}"/>
                </a:ext>
              </a:extLst>
            </p:cNvPr>
            <p:cNvSpPr/>
            <p:nvPr/>
          </p:nvSpPr>
          <p:spPr>
            <a:xfrm>
              <a:off x="5862846" y="6504892"/>
              <a:ext cx="56137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UCS</a:t>
              </a: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EA653204-886F-4AE0-B3E9-0B8427537945}"/>
              </a:ext>
            </a:extLst>
          </p:cNvPr>
          <p:cNvGrpSpPr/>
          <p:nvPr/>
        </p:nvGrpSpPr>
        <p:grpSpPr>
          <a:xfrm>
            <a:off x="360939" y="10033970"/>
            <a:ext cx="2449529" cy="401597"/>
            <a:chOff x="360939" y="8943112"/>
            <a:chExt cx="2449529" cy="401597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623601EF-8AF1-4069-A6CE-4AEC17A6E392}"/>
                </a:ext>
              </a:extLst>
            </p:cNvPr>
            <p:cNvSpPr/>
            <p:nvPr/>
          </p:nvSpPr>
          <p:spPr>
            <a:xfrm>
              <a:off x="360939" y="8975377"/>
              <a:ext cx="66075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UVM</a:t>
              </a: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19771DEB-15DD-4C98-9784-EAF717BB471A}"/>
                </a:ext>
              </a:extLst>
            </p:cNvPr>
            <p:cNvSpPr/>
            <p:nvPr/>
          </p:nvSpPr>
          <p:spPr>
            <a:xfrm>
              <a:off x="2149710" y="8943112"/>
              <a:ext cx="660758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dirty="0"/>
                <a:t>UVM</a:t>
              </a: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B3CCAD61-3DC2-4914-9580-8466DB894367}"/>
              </a:ext>
            </a:extLst>
          </p:cNvPr>
          <p:cNvGrpSpPr/>
          <p:nvPr/>
        </p:nvGrpSpPr>
        <p:grpSpPr>
          <a:xfrm>
            <a:off x="382901" y="152218"/>
            <a:ext cx="6215224" cy="369332"/>
            <a:chOff x="382901" y="10194576"/>
            <a:chExt cx="6215224" cy="369332"/>
          </a:xfrm>
        </p:grpSpPr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36009E2C-8A17-4F54-8408-63AA1B1346DE}"/>
                </a:ext>
              </a:extLst>
            </p:cNvPr>
            <p:cNvSpPr/>
            <p:nvPr/>
          </p:nvSpPr>
          <p:spPr>
            <a:xfrm>
              <a:off x="382901" y="10194576"/>
              <a:ext cx="70403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RAD</a:t>
              </a: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A9FE4577-7EE4-4EA0-A3ED-731054794472}"/>
                </a:ext>
              </a:extLst>
            </p:cNvPr>
            <p:cNvSpPr/>
            <p:nvPr/>
          </p:nvSpPr>
          <p:spPr>
            <a:xfrm>
              <a:off x="2237665" y="10194576"/>
              <a:ext cx="70403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PRAD</a:t>
              </a: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2138ADE7-F82B-45AB-B60F-BCC9517A1ABB}"/>
                </a:ext>
              </a:extLst>
            </p:cNvPr>
            <p:cNvSpPr/>
            <p:nvPr/>
          </p:nvSpPr>
          <p:spPr>
            <a:xfrm>
              <a:off x="4279308" y="10194576"/>
              <a:ext cx="69512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READ</a:t>
              </a: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41E1C001-1324-48D3-BD0C-505F44EE336C}"/>
                </a:ext>
              </a:extLst>
            </p:cNvPr>
            <p:cNvSpPr/>
            <p:nvPr/>
          </p:nvSpPr>
          <p:spPr>
            <a:xfrm>
              <a:off x="5902998" y="10194576"/>
              <a:ext cx="69512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dirty="0"/>
                <a:t>READ</a:t>
              </a:r>
            </a:p>
          </p:txBody>
        </p:sp>
      </p:grpSp>
      <p:pic>
        <p:nvPicPr>
          <p:cNvPr id="33" name="图片 32">
            <a:extLst>
              <a:ext uri="{FF2B5EF4-FFF2-40B4-BE49-F238E27FC236}">
                <a16:creationId xmlns:a16="http://schemas.microsoft.com/office/drawing/2014/main" id="{3AF189AC-432D-4079-A2B1-9133E9C0FC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38163"/>
            <a:ext cx="1620000" cy="1626239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40D88335-5D19-407C-94BB-534F229207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1936" y="440792"/>
            <a:ext cx="1620000" cy="162623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30248C0E-9F20-46DE-A967-265B2FC132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74" y="2297081"/>
            <a:ext cx="1620000" cy="162000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5E5A8B40-BD0B-4E37-BC41-31FCBAF865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21936" y="2297081"/>
            <a:ext cx="1620000" cy="1628318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7E6A91BB-C677-47EF-8988-7B3BE5E2FF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971" y="4227273"/>
            <a:ext cx="1620000" cy="1630425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ADC96CA0-FD67-45A1-9649-578FBFE0D2B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4020" y="4239953"/>
            <a:ext cx="1620000" cy="1632478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93F071BC-222A-4240-9913-F65A489AC0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0" y="6332820"/>
            <a:ext cx="1620000" cy="1615857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35BB684D-1A17-4417-893B-A41EBAE1968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16938" y="6344831"/>
            <a:ext cx="1620000" cy="1628329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0A9376A2-1419-4A92-9CFD-428521D0F74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8408519"/>
            <a:ext cx="1620000" cy="162623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AEC9C554-495B-453D-9331-ED57BA57469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16725" y="8437917"/>
            <a:ext cx="1620000" cy="1628318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42C4EDEF-D8F8-4CCB-B6C2-6D3161D0FE9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971" y="10389218"/>
            <a:ext cx="1620000" cy="1622074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E8DC2058-D94A-478D-9A08-29DC2707BC3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74020" y="2292927"/>
            <a:ext cx="1620000" cy="1624154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DFDC0E19-D977-40A3-AA1E-7371546BAEE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48002" y="408198"/>
            <a:ext cx="1576511" cy="157387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AB5F89F-2640-44B8-B36A-74D3C53243B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279490" y="478449"/>
            <a:ext cx="1514502" cy="1532319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49A7E29D-AB85-43F4-AD9D-30AFD224173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66548" y="2281623"/>
            <a:ext cx="1620001" cy="1630855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6856AF2E-1AF4-43B1-AFE5-39C0CD0AEFD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680423" y="4192659"/>
            <a:ext cx="1661675" cy="1670039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B2B5AB7F-7ABE-4B1F-BA0D-FEFE41D1F2C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401703" y="4279581"/>
            <a:ext cx="1492317" cy="1502315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A4EEC82F-F8D0-4376-896B-306A11F5AD0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747744" y="6344831"/>
            <a:ext cx="1559160" cy="1564392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CB1C92F2-5C0B-4574-B1B3-C27322102F8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238000" y="6309879"/>
            <a:ext cx="1620000" cy="1630891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7E90AE0D-4EBA-42B2-9D5E-343DAAC1E636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696968" y="8391199"/>
            <a:ext cx="1609936" cy="1618067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091ED34B-0E14-456A-96DC-2979FE055BB4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324858" y="8468753"/>
            <a:ext cx="1504310" cy="1511882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27EAD950-6F7F-46E1-BF52-0DB9B455E2BD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779886" y="10403302"/>
            <a:ext cx="1620000" cy="1641855"/>
          </a:xfrm>
          <a:prstGeom prst="rect">
            <a:avLst/>
          </a:prstGeom>
        </p:spPr>
      </p:pic>
      <p:sp>
        <p:nvSpPr>
          <p:cNvPr id="54" name="矩形 53">
            <a:extLst>
              <a:ext uri="{FF2B5EF4-FFF2-40B4-BE49-F238E27FC236}">
                <a16:creationId xmlns:a16="http://schemas.microsoft.com/office/drawing/2014/main" id="{7581ED80-625D-495E-AE74-77E8A9310B96}"/>
              </a:ext>
            </a:extLst>
          </p:cNvPr>
          <p:cNvSpPr/>
          <p:nvPr/>
        </p:nvSpPr>
        <p:spPr>
          <a:xfrm>
            <a:off x="-74896" y="501870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S</a:t>
            </a:r>
            <a:endParaRPr lang="zh-CN" altLang="en-US" dirty="0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E64E3CBA-9411-436E-BCC9-00E757236CAA}"/>
              </a:ext>
            </a:extLst>
          </p:cNvPr>
          <p:cNvSpPr/>
          <p:nvPr/>
        </p:nvSpPr>
        <p:spPr>
          <a:xfrm>
            <a:off x="1722726" y="501870"/>
            <a:ext cx="466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T</a:t>
            </a:r>
            <a:endParaRPr lang="zh-CN" altLang="en-US" dirty="0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F7E2D942-E5B1-4C15-9055-64544930C5EA}"/>
              </a:ext>
            </a:extLst>
          </p:cNvPr>
          <p:cNvSpPr/>
          <p:nvPr/>
        </p:nvSpPr>
        <p:spPr>
          <a:xfrm>
            <a:off x="3353493" y="486259"/>
            <a:ext cx="4616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U</a:t>
            </a:r>
            <a:endParaRPr lang="zh-CN" altLang="en-US" dirty="0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7AA4E320-E7DA-409B-A86F-4251AB48FDB8}"/>
              </a:ext>
            </a:extLst>
          </p:cNvPr>
          <p:cNvSpPr/>
          <p:nvPr/>
        </p:nvSpPr>
        <p:spPr>
          <a:xfrm>
            <a:off x="4956652" y="500665"/>
            <a:ext cx="4391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V</a:t>
            </a:r>
            <a:endParaRPr lang="zh-CN" altLang="en-US" dirty="0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705EFBCF-E809-46B3-B0D9-D51AA7239BA1}"/>
              </a:ext>
            </a:extLst>
          </p:cNvPr>
          <p:cNvSpPr/>
          <p:nvPr/>
        </p:nvSpPr>
        <p:spPr>
          <a:xfrm>
            <a:off x="-73369" y="2517662"/>
            <a:ext cx="5509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W</a:t>
            </a:r>
            <a:endParaRPr lang="zh-CN" altLang="en-US" dirty="0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3578BD8F-6D0C-47D9-9F37-1EDB1338996C}"/>
              </a:ext>
            </a:extLst>
          </p:cNvPr>
          <p:cNvSpPr/>
          <p:nvPr/>
        </p:nvSpPr>
        <p:spPr>
          <a:xfrm>
            <a:off x="1729138" y="2505191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X</a:t>
            </a:r>
            <a:endParaRPr lang="zh-CN" altLang="en-US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0C51B242-61DD-4D2A-8E44-46818F2C8BA9}"/>
              </a:ext>
            </a:extLst>
          </p:cNvPr>
          <p:cNvSpPr/>
          <p:nvPr/>
        </p:nvSpPr>
        <p:spPr>
          <a:xfrm>
            <a:off x="3392928" y="2505191"/>
            <a:ext cx="4969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Y</a:t>
            </a:r>
            <a:endParaRPr lang="zh-CN" altLang="en-US" dirty="0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B1FEB753-3542-4F00-8C9C-4442AD70F79E}"/>
              </a:ext>
            </a:extLst>
          </p:cNvPr>
          <p:cNvSpPr/>
          <p:nvPr/>
        </p:nvSpPr>
        <p:spPr>
          <a:xfrm>
            <a:off x="5031254" y="251952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AZ</a:t>
            </a:r>
            <a:endParaRPr lang="zh-CN" altLang="en-US" dirty="0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5DF6B019-7403-4ECB-A560-37B545072C40}"/>
              </a:ext>
            </a:extLst>
          </p:cNvPr>
          <p:cNvSpPr/>
          <p:nvPr/>
        </p:nvSpPr>
        <p:spPr>
          <a:xfrm>
            <a:off x="-27637" y="445696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A</a:t>
            </a:r>
            <a:endParaRPr lang="zh-CN" altLang="en-US" dirty="0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894E759E-17ED-4CCE-A2C7-DAF03546D559}"/>
              </a:ext>
            </a:extLst>
          </p:cNvPr>
          <p:cNvSpPr/>
          <p:nvPr/>
        </p:nvSpPr>
        <p:spPr>
          <a:xfrm>
            <a:off x="1775607" y="4491342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B</a:t>
            </a:r>
            <a:endParaRPr lang="zh-CN" altLang="en-US" dirty="0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D5E6AC5D-B829-4F84-AAE0-6A89306AC926}"/>
              </a:ext>
            </a:extLst>
          </p:cNvPr>
          <p:cNvSpPr/>
          <p:nvPr/>
        </p:nvSpPr>
        <p:spPr>
          <a:xfrm>
            <a:off x="3413223" y="4469328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C</a:t>
            </a:r>
            <a:endParaRPr lang="zh-CN" altLang="en-US" dirty="0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6D62E3F1-BB50-44B5-8178-37E7BEF04EEB}"/>
              </a:ext>
            </a:extLst>
          </p:cNvPr>
          <p:cNvSpPr/>
          <p:nvPr/>
        </p:nvSpPr>
        <p:spPr>
          <a:xfrm>
            <a:off x="5127783" y="4469328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D</a:t>
            </a:r>
            <a:endParaRPr lang="zh-CN" altLang="en-US" dirty="0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4D87C8C7-4FF5-44C7-ADC4-77D478E6A423}"/>
              </a:ext>
            </a:extLst>
          </p:cNvPr>
          <p:cNvSpPr/>
          <p:nvPr/>
        </p:nvSpPr>
        <p:spPr>
          <a:xfrm>
            <a:off x="-30733" y="8608597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I</a:t>
            </a:r>
            <a:endParaRPr lang="zh-CN" altLang="en-US" dirty="0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16F442F8-B1A8-45DE-8F3A-61DAF97B9FE8}"/>
              </a:ext>
            </a:extLst>
          </p:cNvPr>
          <p:cNvSpPr/>
          <p:nvPr/>
        </p:nvSpPr>
        <p:spPr>
          <a:xfrm>
            <a:off x="1677611" y="8570993"/>
            <a:ext cx="4283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J</a:t>
            </a:r>
            <a:endParaRPr lang="zh-CN" altLang="en-US" dirty="0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57A8A7AC-5DEC-4B36-832E-C498AB1B8E5C}"/>
              </a:ext>
            </a:extLst>
          </p:cNvPr>
          <p:cNvSpPr/>
          <p:nvPr/>
        </p:nvSpPr>
        <p:spPr>
          <a:xfrm>
            <a:off x="43580" y="6504188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E</a:t>
            </a:r>
            <a:endParaRPr lang="zh-CN" altLang="en-US" dirty="0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782B3EFD-F538-4960-818E-C42CAABB351A}"/>
              </a:ext>
            </a:extLst>
          </p:cNvPr>
          <p:cNvSpPr/>
          <p:nvPr/>
        </p:nvSpPr>
        <p:spPr>
          <a:xfrm>
            <a:off x="1696495" y="6519598"/>
            <a:ext cx="4667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F</a:t>
            </a:r>
            <a:endParaRPr lang="zh-CN" altLang="en-US" dirty="0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2B62C589-2026-4FDC-8625-7F84FC435E5A}"/>
              </a:ext>
            </a:extLst>
          </p:cNvPr>
          <p:cNvSpPr/>
          <p:nvPr/>
        </p:nvSpPr>
        <p:spPr>
          <a:xfrm>
            <a:off x="3332901" y="6529344"/>
            <a:ext cx="455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BG</a:t>
            </a:r>
            <a:endParaRPr lang="zh-CN" altLang="en-US" dirty="0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4CD97C4F-1B2F-4510-B0FB-E2F08B42FF7A}"/>
              </a:ext>
            </a:extLst>
          </p:cNvPr>
          <p:cNvSpPr/>
          <p:nvPr/>
        </p:nvSpPr>
        <p:spPr>
          <a:xfrm>
            <a:off x="5041705" y="6069801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H</a:t>
            </a:r>
            <a:endParaRPr lang="zh-CN" altLang="en-US" dirty="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55E2AFD7-9765-43D3-A9DE-A4A142CDB2B2}"/>
              </a:ext>
            </a:extLst>
          </p:cNvPr>
          <p:cNvSpPr/>
          <p:nvPr/>
        </p:nvSpPr>
        <p:spPr>
          <a:xfrm>
            <a:off x="3256450" y="8599642"/>
            <a:ext cx="6492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K</a:t>
            </a:r>
            <a:endParaRPr lang="zh-CN" altLang="en-US" dirty="0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95D37FD6-3ABF-479B-86D2-0121B6BE9A12}"/>
              </a:ext>
            </a:extLst>
          </p:cNvPr>
          <p:cNvSpPr/>
          <p:nvPr/>
        </p:nvSpPr>
        <p:spPr>
          <a:xfrm>
            <a:off x="5113852" y="8201661"/>
            <a:ext cx="4864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BL</a:t>
            </a:r>
            <a:endParaRPr lang="zh-CN" altLang="en-US" dirty="0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0EC36DBC-AE38-4AA3-AA6F-7D2B24E19B58}"/>
              </a:ext>
            </a:extLst>
          </p:cNvPr>
          <p:cNvSpPr/>
          <p:nvPr/>
        </p:nvSpPr>
        <p:spPr>
          <a:xfrm>
            <a:off x="-69411" y="10248186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M</a:t>
            </a:r>
            <a:endParaRPr lang="zh-CN" altLang="en-US" dirty="0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7240FA2C-77CA-4555-96E3-85C6EA1DA674}"/>
              </a:ext>
            </a:extLst>
          </p:cNvPr>
          <p:cNvSpPr/>
          <p:nvPr/>
        </p:nvSpPr>
        <p:spPr>
          <a:xfrm>
            <a:off x="1638933" y="10210582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B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449375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264DEF8D-5C56-463B-AE49-F88A493ABC72}"/>
              </a:ext>
            </a:extLst>
          </p:cNvPr>
          <p:cNvSpPr/>
          <p:nvPr/>
        </p:nvSpPr>
        <p:spPr>
          <a:xfrm>
            <a:off x="147917" y="509053"/>
            <a:ext cx="6562165" cy="78483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</a:t>
            </a:r>
            <a:r>
              <a:rPr lang="en-US" altLang="zh-CN" b="1">
                <a:solidFill>
                  <a:srgbClr val="000000"/>
                </a:solidFill>
                <a:latin typeface="Times New Roman" panose="02020603050405020304" pitchFamily="18" charset="0"/>
              </a:rPr>
              <a:t>Figure 1.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Correlation of </a:t>
            </a:r>
            <a:r>
              <a:rPr lang="en-US" altLang="zh-CN" i="1" dirty="0"/>
              <a:t>HspA1b</a:t>
            </a:r>
            <a:r>
              <a:rPr lang="en-US" altLang="zh-CN" dirty="0"/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expression with prognostic values in diverse types of cancer. Overall survival and disease free curves comparing the high and low expression of </a:t>
            </a:r>
            <a:r>
              <a:rPr lang="en-US" altLang="zh-CN" i="1" dirty="0"/>
              <a:t>HspA1b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 in Adrenocortical carcinoma (ACC) (A-B) , Bladder Urothelial Carcinoma (BLCA) (C-D), Breast invasive carcinoma (BRCA) (E-F), Cervical squamous cell carcinoma and endocervical adenocarcinoma(CESC) (G-H),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olangio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 carcinoma(CHOL) (I-J), Colon adenocarcinoma(COAD) (K-L), Lymphoid Neoplasm Diffuse Large B-cell Lymphoma(DLBC) (M-N), Esophageal carcinoma(ESCA) (O-P), Glioblastoma multiforme(GBM) (Q-R) ,Head and Neck squamous cell carcinoma(HNSC) (S-T), Kidney Chromophobe(KICH) (U-V), Kidney renal clear cell carcinoma(KIRC) (W-X), Kidney renal papillary cell carcinoma(KIRP) (Y-Z), Acute Myeloid Leukemia(LAML) (AA-AB), Brain Lower Grade Glioma(LGG) (AC-AD), Liver hepatocellular carcinoma(LIHC) (AE-AF), Lung adenocarcinoma(LUAD) (AG-AH), Lung squamous cell carcinoma(LUSC) (AI-AJ), Mesothelioma(MESO) (AK-AL), Ovarian serous cystadenocarcinoma(OV) (AM-AN), Pancreatic adenocarcinoma(PAAD) (AO-AP), Pheochromocytoma and Paraganglioma(PCPG) (AQ-AR), Prostate adenocarcinoma(PRAD) (AS-AT), Rectum adenocarcinoma(READ) (AU-AV), Sarcoma(SARC) (AW-AX), Skin Cutaneous Melanoma(SKCM) (AY-AZ), Stomach adenocarcinoma(STAD) (BA-BB), Testicular Germ Cell Tumors(TGCT) (BC-BD), Thyroid carcinoma(THCA) (BE-BF), Thymoma(THYM) (BG-BH), Uterine Corpus Endometrial Carcinoma(UCEC) (BI-BJ), Uterine Carcinosarcoma(UCS) (BK-BL), Uveal Melanoma(UVM) (BM-BN)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9512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1</Words>
  <Application>Microsoft Office PowerPoint</Application>
  <PresentationFormat>宽屏</PresentationFormat>
  <Paragraphs>13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 He</dc:creator>
  <cp:lastModifiedBy>Jian He</cp:lastModifiedBy>
  <cp:revision>97</cp:revision>
  <dcterms:created xsi:type="dcterms:W3CDTF">2019-04-07T06:52:47Z</dcterms:created>
  <dcterms:modified xsi:type="dcterms:W3CDTF">2019-08-05T07:54:20Z</dcterms:modified>
</cp:coreProperties>
</file>